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3405B-F3B6-49A8-8A33-5EF0CAC077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62517-0838-4BEF-ABC4-D78303906E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42C6D-15BF-40F1-BB16-FB970D0BF1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117E5-E852-457D-810E-FA60C923E5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A0688-F4C2-4E37-94D3-BD5A15FFC5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EF098-7307-4092-9E1B-12025F5847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B0E44-D768-4940-9C0F-6601883C50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49696-2FD9-46DD-A5B0-7FA60D2521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46370-5933-43C9-A274-146CDB0F43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2FA2C-E2C2-4FA4-82A4-28EAD1A7B1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1E148-ECCE-4956-963E-C303C67AB6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72F5F5-1398-4604-9207-C858F2DA43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C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C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C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5BA4D0-3B3B-493F-8AEB-10CE430D86E6}" type="slidenum">
              <a:rPr b="0" lang="es-C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Objeto 1" descr=""/>
          <p:cNvPicPr/>
          <p:nvPr/>
        </p:nvPicPr>
        <p:blipFill>
          <a:blip r:embed="rId1"/>
          <a:srcRect l="-2215" t="-3256" r="0" b="-173"/>
          <a:stretch/>
        </p:blipFill>
        <p:spPr>
          <a:xfrm>
            <a:off x="900000" y="189000"/>
            <a:ext cx="7632720" cy="558936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"/>
          <p:cNvSpPr/>
          <p:nvPr/>
        </p:nvSpPr>
        <p:spPr>
          <a:xfrm>
            <a:off x="826920" y="5879160"/>
            <a:ext cx="7488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r>
              <a:rPr b="0" lang="es-C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Categorical traits evaluated in th library on three localities. (a) shows SP_3-1 (bottom) less vigor comparison others MM, (b) SP_5-3 displayed purple branches and petioles, (c) MM parent hairless and (d) SP_10-3 with abundant trichom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19T19:06:23Z</dcterms:created>
  <dc:creator>USUARIO</dc:creator>
  <dc:description/>
  <dc:language>en-US</dc:language>
  <cp:lastModifiedBy>Antonio Monforte Gilabert</cp:lastModifiedBy>
  <dcterms:modified xsi:type="dcterms:W3CDTF">2016-05-19T16:08:07Z</dcterms:modified>
  <cp:revision>15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